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7315200" cy="9144000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pos="230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ntiago, Araceli E *HS" initials="SAE*" lastIdx="3" clrIdx="0"/>
  <p:cmAuthor id="2" name="FR3D" initials="F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7E4BD"/>
    <a:srgbClr val="FFFFFF"/>
    <a:srgbClr val="FDFDFD"/>
    <a:srgbClr val="F1AC2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27" autoAdjust="0"/>
    <p:restoredTop sz="95296" autoAdjust="0"/>
  </p:normalViewPr>
  <p:slideViewPr>
    <p:cSldViewPr>
      <p:cViewPr varScale="1">
        <p:scale>
          <a:sx n="82" d="100"/>
          <a:sy n="82" d="100"/>
        </p:scale>
        <p:origin x="3246" y="126"/>
      </p:cViewPr>
      <p:guideLst>
        <p:guide orient="horz" pos="2880"/>
        <p:guide pos="2160"/>
        <p:guide pos="230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C1DEE1CF-669F-4B9A-ABC4-83D403A420FB}" type="datetimeFigureOut">
              <a:rPr lang="en-US" smtClean="0"/>
              <a:pPr/>
              <a:t>7/2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696913"/>
            <a:ext cx="278765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9ECCB73-6FF5-4618-AD7D-C8C8BF975AE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773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1375" y="696913"/>
            <a:ext cx="278765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ECCB73-6FF5-4618-AD7D-C8C8BF975AE7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01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2840569"/>
            <a:ext cx="621792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97280" y="5181600"/>
            <a:ext cx="512064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5A2332-EC1E-4C26-A652-649246E0DA03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DD8B97-BA5B-4473-B336-E6A3C4B397E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058971-20F8-419F-9DB3-CE0F25B12757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E12439-AF30-4979-9FAE-C529CBF59BB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03520" y="366186"/>
            <a:ext cx="164592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5760" y="366186"/>
            <a:ext cx="481584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467810-9C15-433A-A3AD-70561A34F388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D0CCCC-DF17-48EF-8EC8-2B8DE9E54B7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C5C8FF-F43E-4B9D-BBB1-9CB0DC802C6A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7054F3-28A5-4CC4-8B47-73AB45E629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7851" y="5875867"/>
            <a:ext cx="621792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7851" y="3875619"/>
            <a:ext cx="621792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034312-974F-46E2-9DE1-E61751A6A874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7012C5-9F58-4ED4-9DE3-DCE45765DB3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5760" y="2133602"/>
            <a:ext cx="323088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18560" y="2133602"/>
            <a:ext cx="323088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DCEA2F-DFAD-4459-912A-286BCE7E37E7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27D590-F48F-465F-BD0D-DB3BB9466D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1" y="2046817"/>
            <a:ext cx="3232150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761" y="2899833"/>
            <a:ext cx="3232150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16021" y="2046817"/>
            <a:ext cx="3233420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16021" y="2899833"/>
            <a:ext cx="3233420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103A6A-3A6D-46B9-9FB5-91B7DA9C4920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211031-A53B-4C46-A5C7-BC12B9EE0F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6BEE94-054A-4E60-81C3-43931CB691BD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483786-E860-430E-8386-B22F9F0A45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C85BA7-FD8C-48AF-B8AF-BE41238FD4B4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4A6A5C-B935-4426-8ADF-B9331A4FD84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760" y="364067"/>
            <a:ext cx="2406651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60040" y="364068"/>
            <a:ext cx="4089401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760" y="1913468"/>
            <a:ext cx="2406651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BF28DF-BFF5-4556-8007-DE9BE612C25D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A662FD-E6A2-414B-81A8-A7B0787E43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3830" y="6400801"/>
            <a:ext cx="438912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33830" y="817033"/>
            <a:ext cx="438912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33830" y="7156452"/>
            <a:ext cx="438912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B31992-F892-4942-8E7A-3FE00DA4E143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AFFD31-EC72-4A20-A23C-017F0C589A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65760" y="366713"/>
            <a:ext cx="658368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65760" y="2133600"/>
            <a:ext cx="658368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5760" y="8475664"/>
            <a:ext cx="170688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866EF95-9508-42B2-8CD7-E02222AF2C72}" type="datetimeFigureOut">
              <a:rPr lang="en-US"/>
              <a:pPr>
                <a:defRPr/>
              </a:pPr>
              <a:t>7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9360" y="8475664"/>
            <a:ext cx="231648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42560" y="8475664"/>
            <a:ext cx="170688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EF6D6FA-D1B2-47D7-A5E6-7686954705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21" Type="http://schemas.openxmlformats.org/officeDocument/2006/relationships/image" Target="../media/image19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Group 63"/>
          <p:cNvGrpSpPr/>
          <p:nvPr/>
        </p:nvGrpSpPr>
        <p:grpSpPr>
          <a:xfrm>
            <a:off x="76200" y="206696"/>
            <a:ext cx="7038320" cy="8708704"/>
            <a:chOff x="-218420" y="86535"/>
            <a:chExt cx="7038320" cy="8708704"/>
          </a:xfrm>
        </p:grpSpPr>
        <p:grpSp>
          <p:nvGrpSpPr>
            <p:cNvPr id="71" name="Group 46"/>
            <p:cNvGrpSpPr/>
            <p:nvPr/>
          </p:nvGrpSpPr>
          <p:grpSpPr>
            <a:xfrm>
              <a:off x="292100" y="390525"/>
              <a:ext cx="6489700" cy="1603375"/>
              <a:chOff x="292100" y="390525"/>
              <a:chExt cx="6489700" cy="1603375"/>
            </a:xfrm>
          </p:grpSpPr>
          <p:grpSp>
            <p:nvGrpSpPr>
              <p:cNvPr id="124" name="Group 85"/>
              <p:cNvGrpSpPr/>
              <p:nvPr/>
            </p:nvGrpSpPr>
            <p:grpSpPr>
              <a:xfrm>
                <a:off x="292100" y="390525"/>
                <a:ext cx="6489700" cy="1603375"/>
                <a:chOff x="304800" y="314325"/>
                <a:chExt cx="6489700" cy="1603375"/>
              </a:xfrm>
            </p:grpSpPr>
            <p:pic>
              <p:nvPicPr>
                <p:cNvPr id="126" name="Picture 4" descr="C:\Users\Araceli\NetHood\Pictures\042aatDaap- green\042aatDaap- green.tif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304800" y="314325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27" name="Picture 33" descr="C:\Users\Araceli\NetHood\Pictures\042aap red\042aap red.tif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3568700" y="31750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28" name="Picture 34" descr="C:\Users\Araceli\NetHood\Pictures\042aap blue\042aap blue.tif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1930400" y="31750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29" name="Picture 35" descr="C:\Users\Araceli\NetHood\Pictures\042aap all1\042aap all1_c1+2+3.tif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5194300" y="317500"/>
                  <a:ext cx="1600200" cy="1600200"/>
                </a:xfrm>
                <a:prstGeom prst="rect">
                  <a:avLst/>
                </a:prstGeom>
                <a:noFill/>
              </p:spPr>
            </p:pic>
          </p:grpSp>
          <p:sp>
            <p:nvSpPr>
              <p:cNvPr id="125" name="Rectangle 124"/>
              <p:cNvSpPr/>
              <p:nvPr/>
            </p:nvSpPr>
            <p:spPr>
              <a:xfrm>
                <a:off x="5246082" y="662352"/>
                <a:ext cx="416166" cy="416166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2" name="Group 50"/>
            <p:cNvGrpSpPr/>
            <p:nvPr/>
          </p:nvGrpSpPr>
          <p:grpSpPr>
            <a:xfrm>
              <a:off x="288925" y="2044700"/>
              <a:ext cx="6505575" cy="1619250"/>
              <a:chOff x="288925" y="2044700"/>
              <a:chExt cx="6505575" cy="1619250"/>
            </a:xfrm>
          </p:grpSpPr>
          <p:grpSp>
            <p:nvGrpSpPr>
              <p:cNvPr id="118" name="Group 84"/>
              <p:cNvGrpSpPr/>
              <p:nvPr/>
            </p:nvGrpSpPr>
            <p:grpSpPr>
              <a:xfrm>
                <a:off x="288925" y="2044700"/>
                <a:ext cx="6505575" cy="1619250"/>
                <a:chOff x="314325" y="1981200"/>
                <a:chExt cx="6505575" cy="1619250"/>
              </a:xfrm>
            </p:grpSpPr>
            <p:pic>
              <p:nvPicPr>
                <p:cNvPr id="120" name="Picture 7" descr="C:\Users\Araceli\NetHood\Pictures\042aap-cherry red\042aap-cherry red.tif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3590925" y="1990725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21" name="Picture 8" descr="C:\Users\Araceli\NetHood\Pictures\042aap-cherry green\042aap-cherry green.tif"/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314325" y="200025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22" name="Picture 30" descr="C:\Users\Araceli\NetHood\Pictures\042aatDaap blue1\042aatDaap blue1.tif"/>
                <p:cNvPicPr>
                  <a:picLocks noChangeAspect="1"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1949450" y="198755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23" name="Picture 31" descr="C:\Users\Araceli\NetHood\Pictures\042aap- Cherry all\042aap- Cherry all_c1+2+3.tif"/>
                <p:cNvPicPr>
                  <a:picLocks noChangeAspect="1" noChangeArrowheads="1"/>
                </p:cNvPicPr>
                <p:nvPr/>
              </p:nvPicPr>
              <p:blipFill>
                <a:blip r:embed="rId10" cstate="print"/>
                <a:srcRect/>
                <a:stretch>
                  <a:fillRect/>
                </a:stretch>
              </p:blipFill>
              <p:spPr bwMode="auto">
                <a:xfrm>
                  <a:off x="5219700" y="1981200"/>
                  <a:ext cx="1600200" cy="1600200"/>
                </a:xfrm>
                <a:prstGeom prst="rect">
                  <a:avLst/>
                </a:prstGeom>
                <a:noFill/>
              </p:spPr>
            </p:pic>
          </p:grpSp>
          <p:sp>
            <p:nvSpPr>
              <p:cNvPr id="119" name="Rectangle 118"/>
              <p:cNvSpPr/>
              <p:nvPr/>
            </p:nvSpPr>
            <p:spPr>
              <a:xfrm>
                <a:off x="6172200" y="2520468"/>
                <a:ext cx="457200" cy="416166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3" name="Group 53"/>
            <p:cNvGrpSpPr/>
            <p:nvPr/>
          </p:nvGrpSpPr>
          <p:grpSpPr>
            <a:xfrm>
              <a:off x="5194300" y="3727938"/>
              <a:ext cx="1600200" cy="1612412"/>
              <a:chOff x="5194300" y="3727938"/>
              <a:chExt cx="1600200" cy="1612412"/>
            </a:xfrm>
          </p:grpSpPr>
          <p:pic>
            <p:nvPicPr>
              <p:cNvPr id="116" name="Picture 2" descr="C:\Users\Araceli\NetHood\Pictures\042aatDaap cherry all(4)\042aatDaap cherry all(4)_c1+2+3.tif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5194300" y="3740150"/>
                <a:ext cx="1600200" cy="1600200"/>
              </a:xfrm>
              <a:prstGeom prst="rect">
                <a:avLst/>
              </a:prstGeom>
              <a:noFill/>
            </p:spPr>
          </p:pic>
          <p:sp>
            <p:nvSpPr>
              <p:cNvPr id="117" name="Rectangle 116"/>
              <p:cNvSpPr/>
              <p:nvPr/>
            </p:nvSpPr>
            <p:spPr>
              <a:xfrm>
                <a:off x="5791200" y="3727938"/>
                <a:ext cx="779586" cy="674076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4" name="Group 61"/>
            <p:cNvGrpSpPr/>
            <p:nvPr/>
          </p:nvGrpSpPr>
          <p:grpSpPr>
            <a:xfrm>
              <a:off x="304800" y="5405963"/>
              <a:ext cx="6515100" cy="1617137"/>
              <a:chOff x="304800" y="5405963"/>
              <a:chExt cx="6515100" cy="1617137"/>
            </a:xfrm>
          </p:grpSpPr>
          <p:grpSp>
            <p:nvGrpSpPr>
              <p:cNvPr id="110" name="Group 83"/>
              <p:cNvGrpSpPr/>
              <p:nvPr/>
            </p:nvGrpSpPr>
            <p:grpSpPr>
              <a:xfrm>
                <a:off x="304800" y="5405963"/>
                <a:ext cx="6515100" cy="1617137"/>
                <a:chOff x="304800" y="5317063"/>
                <a:chExt cx="6515100" cy="1617137"/>
              </a:xfrm>
            </p:grpSpPr>
            <p:pic>
              <p:nvPicPr>
                <p:cNvPr id="112" name="Picture 15" descr="C:\Users\Araceli\NetHood\Pictures\042aatCaap-cherry red\042aatCaap-cherry red.tif"/>
                <p:cNvPicPr>
                  <a:picLocks noChangeAspect="1" noChangeArrowheads="1"/>
                </p:cNvPicPr>
                <p:nvPr/>
              </p:nvPicPr>
              <p:blipFill>
                <a:blip r:embed="rId12" cstate="print"/>
                <a:srcRect/>
                <a:stretch>
                  <a:fillRect/>
                </a:stretch>
              </p:blipFill>
              <p:spPr bwMode="auto">
                <a:xfrm>
                  <a:off x="3581400" y="533400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13" name="Picture 16" descr="C:\Users\Araceli\NetHood\Pictures\042aatCaap-cherry green\042aatCaap-cherry green .tif"/>
                <p:cNvPicPr>
                  <a:picLocks noChangeAspect="1" noChangeArrowheads="1"/>
                </p:cNvPicPr>
                <p:nvPr/>
              </p:nvPicPr>
              <p:blipFill>
                <a:blip r:embed="rId13" cstate="print"/>
                <a:srcRect/>
                <a:stretch>
                  <a:fillRect/>
                </a:stretch>
              </p:blipFill>
              <p:spPr bwMode="auto">
                <a:xfrm>
                  <a:off x="304800" y="5317063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14" name="Picture 36" descr="C:\Users\Araceli\NetHood\Pictures\042aatC cherry blue\042aatC cherry blue.tif"/>
                <p:cNvPicPr>
                  <a:picLocks noChangeAspect="1" noChangeArrowheads="1"/>
                </p:cNvPicPr>
                <p:nvPr/>
              </p:nvPicPr>
              <p:blipFill>
                <a:blip r:embed="rId14" cstate="print"/>
                <a:srcRect/>
                <a:stretch>
                  <a:fillRect/>
                </a:stretch>
              </p:blipFill>
              <p:spPr bwMode="auto">
                <a:xfrm>
                  <a:off x="1930400" y="533400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15" name="Picture 37" descr="C:\Users\Araceli\NetHood\Pictures\042aatC cherry  all\042aatC cherry  all_c1+2+3.tif"/>
                <p:cNvPicPr>
                  <a:picLocks noChangeAspect="1" noChangeArrowheads="1"/>
                </p:cNvPicPr>
                <p:nvPr/>
              </p:nvPicPr>
              <p:blipFill>
                <a:blip r:embed="rId15" cstate="print"/>
                <a:srcRect/>
                <a:stretch>
                  <a:fillRect/>
                </a:stretch>
              </p:blipFill>
              <p:spPr bwMode="auto">
                <a:xfrm>
                  <a:off x="5219700" y="5334000"/>
                  <a:ext cx="1600200" cy="1600200"/>
                </a:xfrm>
                <a:prstGeom prst="rect">
                  <a:avLst/>
                </a:prstGeom>
                <a:noFill/>
              </p:spPr>
            </p:pic>
          </p:grpSp>
          <p:sp>
            <p:nvSpPr>
              <p:cNvPr id="111" name="Rectangle 110"/>
              <p:cNvSpPr/>
              <p:nvPr/>
            </p:nvSpPr>
            <p:spPr>
              <a:xfrm>
                <a:off x="5943600" y="5480050"/>
                <a:ext cx="482600" cy="5207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5" name="Group 69"/>
            <p:cNvGrpSpPr/>
            <p:nvPr/>
          </p:nvGrpSpPr>
          <p:grpSpPr>
            <a:xfrm>
              <a:off x="304800" y="7086600"/>
              <a:ext cx="6502400" cy="1600200"/>
              <a:chOff x="304800" y="7086600"/>
              <a:chExt cx="6502400" cy="1600200"/>
            </a:xfrm>
          </p:grpSpPr>
          <p:grpSp>
            <p:nvGrpSpPr>
              <p:cNvPr id="104" name="Group 82"/>
              <p:cNvGrpSpPr/>
              <p:nvPr/>
            </p:nvGrpSpPr>
            <p:grpSpPr>
              <a:xfrm>
                <a:off x="304800" y="7086600"/>
                <a:ext cx="6502400" cy="1600200"/>
                <a:chOff x="304800" y="7086600"/>
                <a:chExt cx="6502400" cy="1600200"/>
              </a:xfrm>
            </p:grpSpPr>
            <p:pic>
              <p:nvPicPr>
                <p:cNvPr id="106" name="Picture 24" descr="C:\Users\Araceli\NetHood\Pictures\pplc green\pplc green.tif"/>
                <p:cNvPicPr>
                  <a:picLocks noChangeAspect="1" noChangeArrowheads="1"/>
                </p:cNvPicPr>
                <p:nvPr/>
              </p:nvPicPr>
              <p:blipFill>
                <a:blip r:embed="rId16" cstate="print"/>
                <a:srcRect/>
                <a:stretch>
                  <a:fillRect/>
                </a:stretch>
              </p:blipFill>
              <p:spPr bwMode="auto">
                <a:xfrm>
                  <a:off x="304800" y="708660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07" name="Picture 25" descr="C:\Users\Araceli\NetHood\Pictures\pplc red\pplc red.tif"/>
                <p:cNvPicPr>
                  <a:picLocks noChangeAspect="1" noChangeArrowheads="1"/>
                </p:cNvPicPr>
                <p:nvPr/>
              </p:nvPicPr>
              <p:blipFill>
                <a:blip r:embed="rId17" cstate="print"/>
                <a:srcRect/>
                <a:stretch>
                  <a:fillRect/>
                </a:stretch>
              </p:blipFill>
              <p:spPr bwMode="auto">
                <a:xfrm>
                  <a:off x="3568700" y="708660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08" name="Picture 38" descr="C:\Users\Araceli\NetHood\Pictures\042 pplc blue\042 pplc blue.tif"/>
                <p:cNvPicPr>
                  <a:picLocks noChangeAspect="1" noChangeArrowheads="1"/>
                </p:cNvPicPr>
                <p:nvPr/>
              </p:nvPicPr>
              <p:blipFill>
                <a:blip r:embed="rId18" cstate="print"/>
                <a:srcRect/>
                <a:stretch>
                  <a:fillRect/>
                </a:stretch>
              </p:blipFill>
              <p:spPr bwMode="auto">
                <a:xfrm>
                  <a:off x="1930400" y="7086600"/>
                  <a:ext cx="1600200" cy="1600200"/>
                </a:xfrm>
                <a:prstGeom prst="rect">
                  <a:avLst/>
                </a:prstGeom>
                <a:noFill/>
              </p:spPr>
            </p:pic>
            <p:pic>
              <p:nvPicPr>
                <p:cNvPr id="109" name="Picture 39" descr="C:\Users\Araceli\NetHood\Pictures\042pplc all\042pplc all_c1+2+3.tif"/>
                <p:cNvPicPr>
                  <a:picLocks noChangeAspect="1" noChangeArrowheads="1"/>
                </p:cNvPicPr>
                <p:nvPr/>
              </p:nvPicPr>
              <p:blipFill>
                <a:blip r:embed="rId19" cstate="print"/>
                <a:srcRect/>
                <a:stretch>
                  <a:fillRect/>
                </a:stretch>
              </p:blipFill>
              <p:spPr bwMode="auto">
                <a:xfrm>
                  <a:off x="5207000" y="7086600"/>
                  <a:ext cx="1600200" cy="1600200"/>
                </a:xfrm>
                <a:prstGeom prst="rect">
                  <a:avLst/>
                </a:prstGeom>
                <a:noFill/>
              </p:spPr>
            </p:pic>
          </p:grpSp>
          <p:sp>
            <p:nvSpPr>
              <p:cNvPr id="105" name="Rectangle 104"/>
              <p:cNvSpPr/>
              <p:nvPr/>
            </p:nvSpPr>
            <p:spPr>
              <a:xfrm>
                <a:off x="5416550" y="7562850"/>
                <a:ext cx="533400" cy="5207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78" name="Picture 5" descr="C:\Users\Araceli\NetHood\Pictures\041aatDaap cherry blue (4)\041aatDaap cherry blue (4).tif"/>
            <p:cNvPicPr>
              <a:picLocks noChangeAspect="1"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1912620" y="3718560"/>
              <a:ext cx="1600200" cy="1600200"/>
            </a:xfrm>
            <a:prstGeom prst="rect">
              <a:avLst/>
            </a:prstGeom>
            <a:noFill/>
          </p:spPr>
        </p:pic>
        <p:pic>
          <p:nvPicPr>
            <p:cNvPr id="79" name="Picture 3" descr="C:\Users\Araceli\NetHood\Pictures\042aatDaap cherry red (4)\042aatDaap cherry red (4).tif"/>
            <p:cNvPicPr>
              <a:picLocks noChangeAspect="1"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3550920" y="3733800"/>
              <a:ext cx="1600200" cy="1600200"/>
            </a:xfrm>
            <a:prstGeom prst="rect">
              <a:avLst/>
            </a:prstGeom>
            <a:noFill/>
          </p:spPr>
        </p:pic>
        <p:pic>
          <p:nvPicPr>
            <p:cNvPr id="80" name="Picture 4" descr="C:\Users\Araceli\NetHood\Pictures\042aatDaap cherry green(4)\042aatDaap cherry green(4).tif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281940" y="3710940"/>
              <a:ext cx="1600200" cy="1600200"/>
            </a:xfrm>
            <a:prstGeom prst="rect">
              <a:avLst/>
            </a:prstGeom>
            <a:noFill/>
          </p:spPr>
        </p:pic>
        <p:sp>
          <p:nvSpPr>
            <p:cNvPr id="82" name="TextBox 81">
              <a:extLst>
                <a:ext uri="{FF2B5EF4-FFF2-40B4-BE49-F238E27FC236}">
                  <a16:creationId xmlns="" xmlns:a16="http://schemas.microsoft.com/office/drawing/2014/main" id="{EA31B5C5-976A-4542-B38E-E5B574A7C7C9}"/>
                </a:ext>
              </a:extLst>
            </p:cNvPr>
            <p:cNvSpPr txBox="1"/>
            <p:nvPr/>
          </p:nvSpPr>
          <p:spPr>
            <a:xfrm rot="16200000">
              <a:off x="-533987" y="836950"/>
              <a:ext cx="137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42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atD </a:t>
              </a:r>
              <a:r>
                <a:rPr lang="en-US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ap</a:t>
              </a:r>
              <a:endParaRPr lang="en-U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="" xmlns:a16="http://schemas.microsoft.com/office/drawing/2014/main" id="{D2A2DB69-ADD9-8948-9D0B-45E4109136C6}"/>
                </a:ext>
              </a:extLst>
            </p:cNvPr>
            <p:cNvSpPr txBox="1"/>
            <p:nvPr/>
          </p:nvSpPr>
          <p:spPr>
            <a:xfrm rot="16200000">
              <a:off x="-968321" y="4102701"/>
              <a:ext cx="202302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42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atD </a:t>
              </a:r>
              <a:r>
                <a:rPr lang="en-US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ap</a:t>
              </a:r>
              <a:endParaRPr lang="en-U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pAap</a:t>
              </a:r>
              <a:r>
                <a:rPr lang="en-US" sz="1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9-cherry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="" xmlns:a16="http://schemas.microsoft.com/office/drawing/2014/main" id="{C6E2BBC4-7295-B04D-B3D0-C5C0373AC66E}"/>
                </a:ext>
              </a:extLst>
            </p:cNvPr>
            <p:cNvSpPr txBox="1"/>
            <p:nvPr/>
          </p:nvSpPr>
          <p:spPr>
            <a:xfrm rot="16200000">
              <a:off x="-990000" y="5876980"/>
              <a:ext cx="2066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42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atD </a:t>
              </a:r>
              <a:r>
                <a:rPr lang="en-US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atC</a:t>
              </a:r>
              <a:endParaRPr lang="en-U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pAap</a:t>
              </a:r>
              <a:r>
                <a:rPr lang="en-US" sz="1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9-cherry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="" xmlns:a16="http://schemas.microsoft.com/office/drawing/2014/main" id="{081622B9-E8DB-DA48-B68D-33C715902E92}"/>
                </a:ext>
              </a:extLst>
            </p:cNvPr>
            <p:cNvSpPr txBox="1"/>
            <p:nvPr/>
          </p:nvSpPr>
          <p:spPr>
            <a:xfrm rot="16200000">
              <a:off x="-734930" y="7755510"/>
              <a:ext cx="15562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42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atD </a:t>
              </a:r>
              <a:r>
                <a:rPr lang="en-US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ap</a:t>
              </a:r>
              <a:endParaRPr lang="en-US" sz="1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pLpp</a:t>
              </a:r>
              <a:r>
                <a:rPr lang="en-US" sz="1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3-cherry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1" name="Group 9">
              <a:extLst>
                <a:ext uri="{FF2B5EF4-FFF2-40B4-BE49-F238E27FC236}">
                  <a16:creationId xmlns="" xmlns:a16="http://schemas.microsoft.com/office/drawing/2014/main" id="{87FDFF48-9994-164F-9440-E99E9B4B174E}"/>
                </a:ext>
              </a:extLst>
            </p:cNvPr>
            <p:cNvGrpSpPr/>
            <p:nvPr/>
          </p:nvGrpSpPr>
          <p:grpSpPr>
            <a:xfrm>
              <a:off x="228600" y="86535"/>
              <a:ext cx="6340281" cy="7381065"/>
              <a:chOff x="300966" y="590259"/>
              <a:chExt cx="5968122" cy="6427674"/>
            </a:xfrm>
          </p:grpSpPr>
          <p:grpSp>
            <p:nvGrpSpPr>
              <p:cNvPr id="94" name="Group 2">
                <a:extLst>
                  <a:ext uri="{FF2B5EF4-FFF2-40B4-BE49-F238E27FC236}">
                    <a16:creationId xmlns="" xmlns:a16="http://schemas.microsoft.com/office/drawing/2014/main" id="{9F1254CB-E91C-5846-95F2-231D21855BF0}"/>
                  </a:ext>
                </a:extLst>
              </p:cNvPr>
              <p:cNvGrpSpPr/>
              <p:nvPr/>
            </p:nvGrpSpPr>
            <p:grpSpPr>
              <a:xfrm>
                <a:off x="327864" y="590259"/>
                <a:ext cx="5941224" cy="334356"/>
                <a:chOff x="327864" y="590259"/>
                <a:chExt cx="5941224" cy="334356"/>
              </a:xfrm>
            </p:grpSpPr>
            <p:sp>
              <p:nvSpPr>
                <p:cNvPr id="99" name="TextBox 98">
                  <a:extLst>
                    <a:ext uri="{FF2B5EF4-FFF2-40B4-BE49-F238E27FC236}">
                      <a16:creationId xmlns="" xmlns:a16="http://schemas.microsoft.com/office/drawing/2014/main" id="{70A08F2D-FF01-B94B-AD73-01A7CDF90413}"/>
                    </a:ext>
                  </a:extLst>
                </p:cNvPr>
                <p:cNvSpPr txBox="1"/>
                <p:nvPr/>
              </p:nvSpPr>
              <p:spPr>
                <a:xfrm>
                  <a:off x="567591" y="646071"/>
                  <a:ext cx="15235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ell membrane</a:t>
                  </a:r>
                </a:p>
              </p:txBody>
            </p:sp>
            <p:sp>
              <p:nvSpPr>
                <p:cNvPr id="100" name="TextBox 99">
                  <a:extLst>
                    <a:ext uri="{FF2B5EF4-FFF2-40B4-BE49-F238E27FC236}">
                      <a16:creationId xmlns="" xmlns:a16="http://schemas.microsoft.com/office/drawing/2014/main" id="{586E7F05-2A0F-1249-BC00-86302B4C5543}"/>
                    </a:ext>
                  </a:extLst>
                </p:cNvPr>
                <p:cNvSpPr txBox="1"/>
                <p:nvPr/>
              </p:nvSpPr>
              <p:spPr>
                <a:xfrm>
                  <a:off x="2166040" y="646072"/>
                  <a:ext cx="12192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ell nucleus</a:t>
                  </a:r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="" xmlns:a16="http://schemas.microsoft.com/office/drawing/2014/main" id="{5AC70B74-11C9-224D-869E-360AC6AF96F5}"/>
                    </a:ext>
                  </a:extLst>
                </p:cNvPr>
                <p:cNvSpPr txBox="1"/>
                <p:nvPr/>
              </p:nvSpPr>
              <p:spPr>
                <a:xfrm>
                  <a:off x="3665367" y="615493"/>
                  <a:ext cx="1226145" cy="241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err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ap-mCherry</a:t>
                  </a:r>
                  <a:endParaRPr 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" name="TextBox 101">
                  <a:extLst>
                    <a:ext uri="{FF2B5EF4-FFF2-40B4-BE49-F238E27FC236}">
                      <a16:creationId xmlns="" xmlns:a16="http://schemas.microsoft.com/office/drawing/2014/main" id="{3EE79B48-5DC1-3949-A486-433D5FF9DDA8}"/>
                    </a:ext>
                  </a:extLst>
                </p:cNvPr>
                <p:cNvSpPr txBox="1"/>
                <p:nvPr/>
              </p:nvSpPr>
              <p:spPr>
                <a:xfrm>
                  <a:off x="5231148" y="647616"/>
                  <a:ext cx="10379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l merged</a:t>
                  </a: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="" xmlns:a16="http://schemas.microsoft.com/office/drawing/2014/main" id="{8A3A31E4-E1B2-B14B-AC38-1F47061A5838}"/>
                    </a:ext>
                  </a:extLst>
                </p:cNvPr>
                <p:cNvSpPr txBox="1"/>
                <p:nvPr/>
              </p:nvSpPr>
              <p:spPr>
                <a:xfrm>
                  <a:off x="327864" y="590259"/>
                  <a:ext cx="4988642" cy="294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>
                      <a:solidFill>
                        <a:schemeClr val="bg1"/>
                      </a:solidFill>
                    </a:rPr>
                    <a:t>A                         </a:t>
                  </a:r>
                  <a:r>
                    <a:rPr lang="en-US" sz="1600" dirty="0" smtClean="0">
                      <a:solidFill>
                        <a:schemeClr val="bg1"/>
                      </a:solidFill>
                    </a:rPr>
                    <a:t>  B                          C                          </a:t>
                  </a:r>
                  <a:r>
                    <a:rPr lang="en-US" sz="1600" dirty="0">
                      <a:solidFill>
                        <a:schemeClr val="bg1"/>
                      </a:solidFill>
                    </a:rPr>
                    <a:t>D</a:t>
                  </a:r>
                </a:p>
              </p:txBody>
            </p:sp>
          </p:grpSp>
          <p:sp>
            <p:nvSpPr>
              <p:cNvPr id="95" name="TextBox 94">
                <a:extLst>
                  <a:ext uri="{FF2B5EF4-FFF2-40B4-BE49-F238E27FC236}">
                    <a16:creationId xmlns="" xmlns:a16="http://schemas.microsoft.com/office/drawing/2014/main" id="{ACD51103-CA59-FA4B-9E5B-424F2E38277D}"/>
                  </a:ext>
                </a:extLst>
              </p:cNvPr>
              <p:cNvSpPr txBox="1"/>
              <p:nvPr/>
            </p:nvSpPr>
            <p:spPr>
              <a:xfrm>
                <a:off x="318898" y="3803301"/>
                <a:ext cx="4960091" cy="294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</a:rPr>
                  <a:t>I                           </a:t>
                </a:r>
                <a:r>
                  <a:rPr lang="en-US" sz="1600" dirty="0" smtClean="0">
                    <a:solidFill>
                      <a:schemeClr val="bg1"/>
                    </a:solidFill>
                  </a:rPr>
                  <a:t> J                           K                          </a:t>
                </a:r>
                <a:r>
                  <a:rPr lang="en-US" sz="1600" dirty="0">
                    <a:solidFill>
                      <a:schemeClr val="bg1"/>
                    </a:solidFill>
                  </a:rPr>
                  <a:t>L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="" xmlns:a16="http://schemas.microsoft.com/office/drawing/2014/main" id="{06795337-8FED-6E48-9A64-7540BD5EF76F}"/>
                  </a:ext>
                </a:extLst>
              </p:cNvPr>
              <p:cNvSpPr txBox="1"/>
              <p:nvPr/>
            </p:nvSpPr>
            <p:spPr>
              <a:xfrm>
                <a:off x="300966" y="5256250"/>
                <a:ext cx="4990269" cy="294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</a:rPr>
                  <a:t>M                        </a:t>
                </a:r>
                <a:r>
                  <a:rPr lang="en-US" sz="1600" dirty="0" smtClean="0">
                    <a:solidFill>
                      <a:schemeClr val="bg1"/>
                    </a:solidFill>
                  </a:rPr>
                  <a:t>  N                          O                          P</a:t>
                </a:r>
                <a:endParaRPr lang="en-US" sz="16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="" xmlns:a16="http://schemas.microsoft.com/office/drawing/2014/main" id="{8EC62BE8-B803-8949-81C2-2DC4BD729F78}"/>
                  </a:ext>
                </a:extLst>
              </p:cNvPr>
              <p:cNvSpPr txBox="1"/>
              <p:nvPr/>
            </p:nvSpPr>
            <p:spPr>
              <a:xfrm>
                <a:off x="312921" y="6723109"/>
                <a:ext cx="4997331" cy="294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</a:rPr>
                  <a:t>Q                        </a:t>
                </a:r>
                <a:r>
                  <a:rPr lang="en-US" sz="1600" dirty="0" smtClean="0">
                    <a:solidFill>
                      <a:schemeClr val="bg1"/>
                    </a:solidFill>
                  </a:rPr>
                  <a:t>  </a:t>
                </a:r>
                <a:r>
                  <a:rPr lang="en-US" sz="1600" dirty="0">
                    <a:solidFill>
                      <a:schemeClr val="bg1"/>
                    </a:solidFill>
                  </a:rPr>
                  <a:t>R                         </a:t>
                </a:r>
                <a:r>
                  <a:rPr lang="en-US" sz="1600" dirty="0" smtClean="0">
                    <a:solidFill>
                      <a:schemeClr val="bg1"/>
                    </a:solidFill>
                  </a:rPr>
                  <a:t> S                           T</a:t>
                </a:r>
                <a:endParaRPr lang="en-US" sz="16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="" xmlns:a16="http://schemas.microsoft.com/office/drawing/2014/main" id="{FCAC5143-DD14-BF4B-8E9C-D5702C529B15}"/>
                  </a:ext>
                </a:extLst>
              </p:cNvPr>
              <p:cNvSpPr txBox="1"/>
              <p:nvPr/>
            </p:nvSpPr>
            <p:spPr>
              <a:xfrm>
                <a:off x="300966" y="2334583"/>
                <a:ext cx="5055155" cy="294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</a:rPr>
                  <a:t>E                         </a:t>
                </a:r>
                <a:r>
                  <a:rPr lang="en-US" sz="1600" dirty="0" smtClean="0">
                    <a:solidFill>
                      <a:schemeClr val="bg1"/>
                    </a:solidFill>
                  </a:rPr>
                  <a:t>  F                           G                         H</a:t>
                </a:r>
                <a:endParaRPr lang="en-US" sz="16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92" name="TextBox 91">
              <a:extLst>
                <a:ext uri="{FF2B5EF4-FFF2-40B4-BE49-F238E27FC236}">
                  <a16:creationId xmlns="" xmlns:a16="http://schemas.microsoft.com/office/drawing/2014/main" id="{9E771A0C-E6A7-1F41-A468-5E3E66EAAFFF}"/>
                </a:ext>
              </a:extLst>
            </p:cNvPr>
            <p:cNvSpPr txBox="1"/>
            <p:nvPr/>
          </p:nvSpPr>
          <p:spPr>
            <a:xfrm rot="16200000">
              <a:off x="-772794" y="2490151"/>
              <a:ext cx="166274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42</a:t>
              </a:r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ap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Aap</a:t>
              </a:r>
              <a:r>
                <a:rPr lang="en-US" sz="1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9-cherr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="" xmlns:a16="http://schemas.microsoft.com/office/drawing/2014/main" id="{FCAC5143-DD14-BF4B-8E9C-D5702C529B15}"/>
                </a:ext>
              </a:extLst>
            </p:cNvPr>
            <p:cNvSpPr txBox="1"/>
            <p:nvPr/>
          </p:nvSpPr>
          <p:spPr>
            <a:xfrm>
              <a:off x="228600" y="355600"/>
              <a:ext cx="53894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solidFill>
                    <a:schemeClr val="bg1"/>
                  </a:solidFill>
                </a:rPr>
                <a:t>A                           B                          C                          D</a:t>
              </a:r>
              <a:endParaRPr lang="en-US" sz="16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26035166"/>
      </p:ext>
    </p:extLst>
  </p:cSld>
  <p:clrMapOvr>
    <a:masterClrMapping/>
  </p:clrMapOvr>
</p:sld>
</file>

<file path=ppt/theme/theme1.xml><?xml version="1.0" encoding="utf-8"?>
<a:theme xmlns:a="http://schemas.openxmlformats.org/drawingml/2006/main" name="FIGURES june ho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IGURES 06 24 16" id="{F0523895-CD17-4945-A504-9D4E646E66E5}" vid="{8F619E1E-F439-9649-A974-F0E745BA01D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03860</TotalTime>
  <Words>53</Words>
  <Application>Microsoft Office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FIGURES june home</vt:lpstr>
      <vt:lpstr>PowerPoint Presentation</vt:lpstr>
    </vt:vector>
  </TitlesOfParts>
  <Company>Univeristy of Virginia Health Syste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ES8J</dc:creator>
  <cp:lastModifiedBy>Santiago, Araceli E *HS</cp:lastModifiedBy>
  <cp:revision>3757</cp:revision>
  <cp:lastPrinted>2020-03-31T20:39:38Z</cp:lastPrinted>
  <dcterms:created xsi:type="dcterms:W3CDTF">2016-06-27T11:24:37Z</dcterms:created>
  <dcterms:modified xsi:type="dcterms:W3CDTF">2020-07-27T22:26:19Z</dcterms:modified>
</cp:coreProperties>
</file>